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430B5D-4A3A-4916-BCFC-8554E4E784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661FC7-FD38-45F2-9CD6-0B57CE206C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7340B-EB52-463B-996E-1CACAAFB02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8CC6BD-467D-4359-B9DA-E4A69799F2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520D9-855E-45BF-8D92-FD0AAB3D2D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A08E72-2181-41E5-8BB5-F7C3F5ADBE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B9E5C7-26CA-4412-8596-A2068F0E94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2DFD8C-EFA5-4A8E-A655-477090A2D9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ECA45-8FBD-46E8-9E5B-424264651A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CF284-66C0-48E8-81BB-913D3EDB2A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E5EBAD-9536-4D7F-BA67-008D7F3AB8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9B73C4-5CBD-4D59-99E4-4CD582BB46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2C5586-B66D-4AA2-8310-158883005D6A}" type="slidenum">
              <a:rPr b="0" lang="en-AU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8"/>
          <p:cNvGrpSpPr/>
          <p:nvPr/>
        </p:nvGrpSpPr>
        <p:grpSpPr>
          <a:xfrm>
            <a:off x="146160" y="404640"/>
            <a:ext cx="8673480" cy="6408720"/>
            <a:chOff x="146160" y="404640"/>
            <a:chExt cx="8673480" cy="6408720"/>
          </a:xfrm>
        </p:grpSpPr>
        <p:pic>
          <p:nvPicPr>
            <p:cNvPr id="42" name="Picture 3" descr="TF_0"/>
            <p:cNvPicPr/>
            <p:nvPr/>
          </p:nvPicPr>
          <p:blipFill>
            <a:blip r:embed="rId1"/>
            <a:srcRect l="1169" t="4505" r="24002" b="27282"/>
            <a:stretch/>
          </p:blipFill>
          <p:spPr>
            <a:xfrm>
              <a:off x="211320" y="4215240"/>
              <a:ext cx="4598280" cy="255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4" descr="KIN_0"/>
            <p:cNvPicPr/>
            <p:nvPr/>
          </p:nvPicPr>
          <p:blipFill>
            <a:blip r:embed="rId2"/>
            <a:srcRect l="8260" t="18960" r="60242" b="28534"/>
            <a:stretch/>
          </p:blipFill>
          <p:spPr>
            <a:xfrm>
              <a:off x="5708880" y="4391280"/>
              <a:ext cx="2072520" cy="2108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7" descr="PTM_0"/>
            <p:cNvPicPr/>
            <p:nvPr/>
          </p:nvPicPr>
          <p:blipFill>
            <a:blip r:embed="rId3"/>
            <a:srcRect l="11416" t="3385" r="27937" b="0"/>
            <a:stretch/>
          </p:blipFill>
          <p:spPr>
            <a:xfrm>
              <a:off x="4876560" y="471960"/>
              <a:ext cx="3943080" cy="3765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Rectangle 8"/>
            <p:cNvSpPr/>
            <p:nvPr/>
          </p:nvSpPr>
          <p:spPr>
            <a:xfrm>
              <a:off x="4879800" y="404640"/>
              <a:ext cx="3939840" cy="3792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6" name="Picture 6" descr="SEC_0"/>
            <p:cNvPicPr/>
            <p:nvPr/>
          </p:nvPicPr>
          <p:blipFill>
            <a:blip r:embed="rId4"/>
            <a:srcRect l="7481" t="1940" r="13754" b="0"/>
            <a:stretch/>
          </p:blipFill>
          <p:spPr>
            <a:xfrm>
              <a:off x="178920" y="515160"/>
              <a:ext cx="4491720" cy="3410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7" name="Rectangle 9"/>
            <p:cNvSpPr/>
            <p:nvPr/>
          </p:nvSpPr>
          <p:spPr>
            <a:xfrm>
              <a:off x="178920" y="429840"/>
              <a:ext cx="4493160" cy="36327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10"/>
            <p:cNvSpPr/>
            <p:nvPr/>
          </p:nvSpPr>
          <p:spPr>
            <a:xfrm>
              <a:off x="248040" y="4197240"/>
              <a:ext cx="4561560" cy="26161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1"/>
            <p:cNvSpPr/>
            <p:nvPr/>
          </p:nvSpPr>
          <p:spPr>
            <a:xfrm>
              <a:off x="5362920" y="4400640"/>
              <a:ext cx="2834640" cy="21679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14"/>
            <p:cNvSpPr/>
            <p:nvPr/>
          </p:nvSpPr>
          <p:spPr>
            <a:xfrm>
              <a:off x="146160" y="4046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5"/>
            <p:cNvSpPr/>
            <p:nvPr/>
          </p:nvSpPr>
          <p:spPr>
            <a:xfrm>
              <a:off x="4881600" y="4046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16"/>
            <p:cNvSpPr/>
            <p:nvPr/>
          </p:nvSpPr>
          <p:spPr>
            <a:xfrm>
              <a:off x="190080" y="413028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7"/>
            <p:cNvSpPr/>
            <p:nvPr/>
          </p:nvSpPr>
          <p:spPr>
            <a:xfrm>
              <a:off x="5364720" y="44006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AU" sz="18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Rectangle 20"/>
          <p:cNvSpPr/>
          <p:nvPr/>
        </p:nvSpPr>
        <p:spPr>
          <a:xfrm>
            <a:off x="0" y="14400"/>
            <a:ext cx="8964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Additional File 5.  A Boolean-based systems biology approach to predict novel genes associated with cancer: Application to colorectal cancer- Shivashankar H Nagaraj and Antonio Reverte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05T06:45:42Z</dcterms:created>
  <dc:creator>Hiriyur-Nagaraj, Shivashankar (LI, St. Lucia)</dc:creator>
  <dc:description/>
  <dc:language>en-US</dc:language>
  <cp:lastModifiedBy>Hiriyur-Nagaraj, Shivashankar (LI, St. Lucia)</cp:lastModifiedBy>
  <dcterms:modified xsi:type="dcterms:W3CDTF">2011-02-22T23:42:46Z</dcterms:modified>
  <cp:revision>6</cp:revision>
  <dc:subject/>
  <dc:title>Slide 1</dc:title>
</cp:coreProperties>
</file>